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D41EB1C-AC0C-4932-8C2F-50E6CF40FB90}" v="8" dt="2025-10-17T08:34:43.5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1554" y="-16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dori IKEZAKI" userId="fd67c7cb21f100c9" providerId="LiveId" clId="{3A9434AE-C88A-430D-81D2-E32D4B38066A}"/>
    <pc:docChg chg="undo redo custSel modSld">
      <pc:chgData name="Midori IKEZAKI" userId="fd67c7cb21f100c9" providerId="LiveId" clId="{3A9434AE-C88A-430D-81D2-E32D4B38066A}" dt="2025-10-17T09:33:17.475" v="369" actId="208"/>
      <pc:docMkLst>
        <pc:docMk/>
      </pc:docMkLst>
      <pc:sldChg chg="addSp delSp modSp mod">
        <pc:chgData name="Midori IKEZAKI" userId="fd67c7cb21f100c9" providerId="LiveId" clId="{3A9434AE-C88A-430D-81D2-E32D4B38066A}" dt="2025-10-17T09:33:17.475" v="369" actId="208"/>
        <pc:sldMkLst>
          <pc:docMk/>
          <pc:sldMk cId="3488421163" sldId="256"/>
        </pc:sldMkLst>
        <pc:spChg chg="mod">
          <ac:chgData name="Midori IKEZAKI" userId="fd67c7cb21f100c9" providerId="LiveId" clId="{3A9434AE-C88A-430D-81D2-E32D4B38066A}" dt="2025-10-17T08:41:07.768" v="241" actId="552"/>
          <ac:spMkLst>
            <pc:docMk/>
            <pc:sldMk cId="3488421163" sldId="256"/>
            <ac:spMk id="3" creationId="{8D573505-69E2-F1D2-8E9F-55E752B7BB4B}"/>
          </ac:spMkLst>
        </pc:spChg>
        <pc:spChg chg="mod">
          <ac:chgData name="Midori IKEZAKI" userId="fd67c7cb21f100c9" providerId="LiveId" clId="{3A9434AE-C88A-430D-81D2-E32D4B38066A}" dt="2025-10-17T08:42:04.843" v="263" actId="1036"/>
          <ac:spMkLst>
            <pc:docMk/>
            <pc:sldMk cId="3488421163" sldId="256"/>
            <ac:spMk id="5" creationId="{6EB9518A-CAE2-6D0B-7EC5-E9FF94289598}"/>
          </ac:spMkLst>
        </pc:spChg>
        <pc:spChg chg="del mod">
          <ac:chgData name="Midori IKEZAKI" userId="fd67c7cb21f100c9" providerId="LiveId" clId="{3A9434AE-C88A-430D-81D2-E32D4B38066A}" dt="2025-10-17T08:38:10.812" v="166" actId="478"/>
          <ac:spMkLst>
            <pc:docMk/>
            <pc:sldMk cId="3488421163" sldId="256"/>
            <ac:spMk id="7" creationId="{E7A62D8F-19DC-D140-1330-66D07D3A6FE4}"/>
          </ac:spMkLst>
        </pc:spChg>
        <pc:spChg chg="del mod">
          <ac:chgData name="Midori IKEZAKI" userId="fd67c7cb21f100c9" providerId="LiveId" clId="{3A9434AE-C88A-430D-81D2-E32D4B38066A}" dt="2025-10-17T08:37:23.572" v="163" actId="478"/>
          <ac:spMkLst>
            <pc:docMk/>
            <pc:sldMk cId="3488421163" sldId="256"/>
            <ac:spMk id="9" creationId="{0A514260-0C84-9B14-9E5C-634DFBD7B2C4}"/>
          </ac:spMkLst>
        </pc:spChg>
        <pc:spChg chg="del mod">
          <ac:chgData name="Midori IKEZAKI" userId="fd67c7cb21f100c9" providerId="LiveId" clId="{3A9434AE-C88A-430D-81D2-E32D4B38066A}" dt="2025-10-17T08:38:16.989" v="167" actId="478"/>
          <ac:spMkLst>
            <pc:docMk/>
            <pc:sldMk cId="3488421163" sldId="256"/>
            <ac:spMk id="11" creationId="{55134CB4-E86D-A59B-85A7-0C48AA7BDEC6}"/>
          </ac:spMkLst>
        </pc:spChg>
        <pc:spChg chg="add mod">
          <ac:chgData name="Midori IKEZAKI" userId="fd67c7cb21f100c9" providerId="LiveId" clId="{3A9434AE-C88A-430D-81D2-E32D4B38066A}" dt="2025-10-17T09:31:52.559" v="353" actId="1076"/>
          <ac:spMkLst>
            <pc:docMk/>
            <pc:sldMk cId="3488421163" sldId="256"/>
            <ac:spMk id="12" creationId="{D3973391-A468-ACBF-236D-043F6321C1FB}"/>
          </ac:spMkLst>
        </pc:spChg>
        <pc:spChg chg="mod">
          <ac:chgData name="Midori IKEZAKI" userId="fd67c7cb21f100c9" providerId="LiveId" clId="{3A9434AE-C88A-430D-81D2-E32D4B38066A}" dt="2025-10-17T08:39:47.033" v="194" actId="552"/>
          <ac:spMkLst>
            <pc:docMk/>
            <pc:sldMk cId="3488421163" sldId="256"/>
            <ac:spMk id="13" creationId="{E9AFF4E7-D4FF-E0E0-2529-D8F6F66AB7F5}"/>
          </ac:spMkLst>
        </pc:spChg>
        <pc:spChg chg="add mod">
          <ac:chgData name="Midori IKEZAKI" userId="fd67c7cb21f100c9" providerId="LiveId" clId="{3A9434AE-C88A-430D-81D2-E32D4B38066A}" dt="2025-10-17T09:32:52.345" v="366" actId="1076"/>
          <ac:spMkLst>
            <pc:docMk/>
            <pc:sldMk cId="3488421163" sldId="256"/>
            <ac:spMk id="14" creationId="{BE4280CB-753E-A1DF-90A3-90CF988B7A1A}"/>
          </ac:spMkLst>
        </pc:spChg>
        <pc:spChg chg="del">
          <ac:chgData name="Midori IKEZAKI" userId="fd67c7cb21f100c9" providerId="LiveId" clId="{3A9434AE-C88A-430D-81D2-E32D4B38066A}" dt="2025-10-17T08:26:35.337" v="81" actId="478"/>
          <ac:spMkLst>
            <pc:docMk/>
            <pc:sldMk cId="3488421163" sldId="256"/>
            <ac:spMk id="15" creationId="{0F74D8B5-43C1-0A7F-A091-A3E9F93C7535}"/>
          </ac:spMkLst>
        </pc:spChg>
        <pc:spChg chg="mod ord">
          <ac:chgData name="Midori IKEZAKI" userId="fd67c7cb21f100c9" providerId="LiveId" clId="{3A9434AE-C88A-430D-81D2-E32D4B38066A}" dt="2025-10-17T08:35:54.980" v="152" actId="1076"/>
          <ac:spMkLst>
            <pc:docMk/>
            <pc:sldMk cId="3488421163" sldId="256"/>
            <ac:spMk id="17" creationId="{C87300B2-D62E-F008-BB10-4F2D6D9FCE15}"/>
          </ac:spMkLst>
        </pc:spChg>
        <pc:spChg chg="add mod">
          <ac:chgData name="Midori IKEZAKI" userId="fd67c7cb21f100c9" providerId="LiveId" clId="{3A9434AE-C88A-430D-81D2-E32D4B38066A}" dt="2025-10-17T08:42:04.843" v="263" actId="1036"/>
          <ac:spMkLst>
            <pc:docMk/>
            <pc:sldMk cId="3488421163" sldId="256"/>
            <ac:spMk id="18" creationId="{134CEBAE-4CAA-CD76-CA8F-1CFAC9266987}"/>
          </ac:spMkLst>
        </pc:spChg>
        <pc:spChg chg="add del mod">
          <ac:chgData name="Midori IKEZAKI" userId="fd67c7cb21f100c9" providerId="LiveId" clId="{3A9434AE-C88A-430D-81D2-E32D4B38066A}" dt="2025-10-17T08:38:10.812" v="166" actId="478"/>
          <ac:spMkLst>
            <pc:docMk/>
            <pc:sldMk cId="3488421163" sldId="256"/>
            <ac:spMk id="19" creationId="{E27F718F-5D7C-6BE4-7D88-920C455EDBB9}"/>
          </ac:spMkLst>
        </pc:spChg>
        <pc:spChg chg="add mod">
          <ac:chgData name="Midori IKEZAKI" userId="fd67c7cb21f100c9" providerId="LiveId" clId="{3A9434AE-C88A-430D-81D2-E32D4B38066A}" dt="2025-10-17T08:42:04.843" v="263" actId="1036"/>
          <ac:spMkLst>
            <pc:docMk/>
            <pc:sldMk cId="3488421163" sldId="256"/>
            <ac:spMk id="26" creationId="{50C7B2F7-0C9D-72E3-0414-26EF9523BC6E}"/>
          </ac:spMkLst>
        </pc:spChg>
        <pc:spChg chg="add mod">
          <ac:chgData name="Midori IKEZAKI" userId="fd67c7cb21f100c9" providerId="LiveId" clId="{3A9434AE-C88A-430D-81D2-E32D4B38066A}" dt="2025-10-17T08:42:04.843" v="263" actId="1036"/>
          <ac:spMkLst>
            <pc:docMk/>
            <pc:sldMk cId="3488421163" sldId="256"/>
            <ac:spMk id="27" creationId="{9C7E0361-1131-C93C-4B7B-7E667B4D9C7F}"/>
          </ac:spMkLst>
        </pc:spChg>
        <pc:spChg chg="add del mod">
          <ac:chgData name="Midori IKEZAKI" userId="fd67c7cb21f100c9" providerId="LiveId" clId="{3A9434AE-C88A-430D-81D2-E32D4B38066A}" dt="2025-10-17T08:38:10.812" v="166" actId="478"/>
          <ac:spMkLst>
            <pc:docMk/>
            <pc:sldMk cId="3488421163" sldId="256"/>
            <ac:spMk id="28" creationId="{0D889ED0-46EE-6E9F-674B-BC936ED46B79}"/>
          </ac:spMkLst>
        </pc:spChg>
        <pc:spChg chg="add mod topLvl">
          <ac:chgData name="Midori IKEZAKI" userId="fd67c7cb21f100c9" providerId="LiveId" clId="{3A9434AE-C88A-430D-81D2-E32D4B38066A}" dt="2025-10-17T08:42:10.113" v="268" actId="1035"/>
          <ac:spMkLst>
            <pc:docMk/>
            <pc:sldMk cId="3488421163" sldId="256"/>
            <ac:spMk id="29" creationId="{EAC5F521-F40E-43E1-E0CE-F6AB1E6AFD4E}"/>
          </ac:spMkLst>
        </pc:spChg>
        <pc:spChg chg="add mod topLvl">
          <ac:chgData name="Midori IKEZAKI" userId="fd67c7cb21f100c9" providerId="LiveId" clId="{3A9434AE-C88A-430D-81D2-E32D4B38066A}" dt="2025-10-17T08:42:10.113" v="268" actId="1035"/>
          <ac:spMkLst>
            <pc:docMk/>
            <pc:sldMk cId="3488421163" sldId="256"/>
            <ac:spMk id="30" creationId="{1AD1522D-9908-49D9-4F6B-AD39C4D99F65}"/>
          </ac:spMkLst>
        </pc:spChg>
        <pc:spChg chg="add del mod topLvl">
          <ac:chgData name="Midori IKEZAKI" userId="fd67c7cb21f100c9" providerId="LiveId" clId="{3A9434AE-C88A-430D-81D2-E32D4B38066A}" dt="2025-10-17T08:40:36.806" v="231" actId="478"/>
          <ac:spMkLst>
            <pc:docMk/>
            <pc:sldMk cId="3488421163" sldId="256"/>
            <ac:spMk id="31" creationId="{0EAC59D8-E594-4056-0E5E-23A80EB096FD}"/>
          </ac:spMkLst>
        </pc:spChg>
        <pc:spChg chg="add mod topLvl">
          <ac:chgData name="Midori IKEZAKI" userId="fd67c7cb21f100c9" providerId="LiveId" clId="{3A9434AE-C88A-430D-81D2-E32D4B38066A}" dt="2025-10-17T08:42:10.113" v="268" actId="1035"/>
          <ac:spMkLst>
            <pc:docMk/>
            <pc:sldMk cId="3488421163" sldId="256"/>
            <ac:spMk id="32" creationId="{163C0BB3-E283-30AF-2B29-B1B9AE05D7B6}"/>
          </ac:spMkLst>
        </pc:spChg>
        <pc:spChg chg="add mod ord topLvl">
          <ac:chgData name="Midori IKEZAKI" userId="fd67c7cb21f100c9" providerId="LiveId" clId="{3A9434AE-C88A-430D-81D2-E32D4B38066A}" dt="2025-10-17T08:46:26.704" v="306" actId="1076"/>
          <ac:spMkLst>
            <pc:docMk/>
            <pc:sldMk cId="3488421163" sldId="256"/>
            <ac:spMk id="36" creationId="{D2756521-44B3-26A3-A682-7F164C0778C7}"/>
          </ac:spMkLst>
        </pc:spChg>
        <pc:spChg chg="add mod topLvl">
          <ac:chgData name="Midori IKEZAKI" userId="fd67c7cb21f100c9" providerId="LiveId" clId="{3A9434AE-C88A-430D-81D2-E32D4B38066A}" dt="2025-10-17T08:47:32.654" v="317" actId="1076"/>
          <ac:spMkLst>
            <pc:docMk/>
            <pc:sldMk cId="3488421163" sldId="256"/>
            <ac:spMk id="37" creationId="{D668C4BC-406A-5417-8227-C4A33A78EDDA}"/>
          </ac:spMkLst>
        </pc:spChg>
        <pc:spChg chg="add del mod topLvl">
          <ac:chgData name="Midori IKEZAKI" userId="fd67c7cb21f100c9" providerId="LiveId" clId="{3A9434AE-C88A-430D-81D2-E32D4B38066A}" dt="2025-10-17T08:39:31.913" v="183" actId="478"/>
          <ac:spMkLst>
            <pc:docMk/>
            <pc:sldMk cId="3488421163" sldId="256"/>
            <ac:spMk id="38" creationId="{6F0BB11B-BF37-7921-0FD3-696FB76C7464}"/>
          </ac:spMkLst>
        </pc:spChg>
        <pc:spChg chg="add mod">
          <ac:chgData name="Midori IKEZAKI" userId="fd67c7cb21f100c9" providerId="LiveId" clId="{3A9434AE-C88A-430D-81D2-E32D4B38066A}" dt="2025-10-17T08:38:42.861" v="174"/>
          <ac:spMkLst>
            <pc:docMk/>
            <pc:sldMk cId="3488421163" sldId="256"/>
            <ac:spMk id="40" creationId="{78537C57-3438-9B56-3C28-919D9D7B2AB6}"/>
          </ac:spMkLst>
        </pc:spChg>
        <pc:spChg chg="add mod">
          <ac:chgData name="Midori IKEZAKI" userId="fd67c7cb21f100c9" providerId="LiveId" clId="{3A9434AE-C88A-430D-81D2-E32D4B38066A}" dt="2025-10-17T08:38:42.861" v="174"/>
          <ac:spMkLst>
            <pc:docMk/>
            <pc:sldMk cId="3488421163" sldId="256"/>
            <ac:spMk id="41" creationId="{35D14279-E6F4-16ED-523B-D68CBCC70E3D}"/>
          </ac:spMkLst>
        </pc:spChg>
        <pc:spChg chg="add mod">
          <ac:chgData name="Midori IKEZAKI" userId="fd67c7cb21f100c9" providerId="LiveId" clId="{3A9434AE-C88A-430D-81D2-E32D4B38066A}" dt="2025-10-17T08:38:42.861" v="174"/>
          <ac:spMkLst>
            <pc:docMk/>
            <pc:sldMk cId="3488421163" sldId="256"/>
            <ac:spMk id="42" creationId="{26BE2E1F-C5D2-B42E-BABB-5C227CE1BBFB}"/>
          </ac:spMkLst>
        </pc:spChg>
        <pc:spChg chg="add mod">
          <ac:chgData name="Midori IKEZAKI" userId="fd67c7cb21f100c9" providerId="LiveId" clId="{3A9434AE-C88A-430D-81D2-E32D4B38066A}" dt="2025-10-17T08:38:42.861" v="174"/>
          <ac:spMkLst>
            <pc:docMk/>
            <pc:sldMk cId="3488421163" sldId="256"/>
            <ac:spMk id="43" creationId="{96E46E65-6B42-9B48-D5C8-1020D518F6B4}"/>
          </ac:spMkLst>
        </pc:spChg>
        <pc:spChg chg="add mod">
          <ac:chgData name="Midori IKEZAKI" userId="fd67c7cb21f100c9" providerId="LiveId" clId="{3A9434AE-C88A-430D-81D2-E32D4B38066A}" dt="2025-10-17T08:38:42.861" v="174"/>
          <ac:spMkLst>
            <pc:docMk/>
            <pc:sldMk cId="3488421163" sldId="256"/>
            <ac:spMk id="47" creationId="{CB26733F-98BB-4B19-B3FF-F131859AF6B7}"/>
          </ac:spMkLst>
        </pc:spChg>
        <pc:spChg chg="add mod">
          <ac:chgData name="Midori IKEZAKI" userId="fd67c7cb21f100c9" providerId="LiveId" clId="{3A9434AE-C88A-430D-81D2-E32D4B38066A}" dt="2025-10-17T08:38:42.861" v="174"/>
          <ac:spMkLst>
            <pc:docMk/>
            <pc:sldMk cId="3488421163" sldId="256"/>
            <ac:spMk id="48" creationId="{66838EF6-E32C-EAE7-DA97-2A03C57388E5}"/>
          </ac:spMkLst>
        </pc:spChg>
        <pc:spChg chg="add mod">
          <ac:chgData name="Midori IKEZAKI" userId="fd67c7cb21f100c9" providerId="LiveId" clId="{3A9434AE-C88A-430D-81D2-E32D4B38066A}" dt="2025-10-17T08:38:42.861" v="174"/>
          <ac:spMkLst>
            <pc:docMk/>
            <pc:sldMk cId="3488421163" sldId="256"/>
            <ac:spMk id="49" creationId="{914B99CD-AD58-DECB-E980-BA4BA893BD88}"/>
          </ac:spMkLst>
        </pc:spChg>
        <pc:spChg chg="mod topLvl">
          <ac:chgData name="Midori IKEZAKI" userId="fd67c7cb21f100c9" providerId="LiveId" clId="{3A9434AE-C88A-430D-81D2-E32D4B38066A}" dt="2025-10-17T08:42:10.113" v="268" actId="1035"/>
          <ac:spMkLst>
            <pc:docMk/>
            <pc:sldMk cId="3488421163" sldId="256"/>
            <ac:spMk id="51" creationId="{ECC1F5FF-424A-1FCD-61DE-15821A5F2DC3}"/>
          </ac:spMkLst>
        </pc:spChg>
        <pc:spChg chg="mod topLvl">
          <ac:chgData name="Midori IKEZAKI" userId="fd67c7cb21f100c9" providerId="LiveId" clId="{3A9434AE-C88A-430D-81D2-E32D4B38066A}" dt="2025-10-17T08:42:10.113" v="268" actId="1035"/>
          <ac:spMkLst>
            <pc:docMk/>
            <pc:sldMk cId="3488421163" sldId="256"/>
            <ac:spMk id="52" creationId="{CFDFE399-9CBB-18E8-65E9-51FE8298F899}"/>
          </ac:spMkLst>
        </pc:spChg>
        <pc:spChg chg="del mod">
          <ac:chgData name="Midori IKEZAKI" userId="fd67c7cb21f100c9" providerId="LiveId" clId="{3A9434AE-C88A-430D-81D2-E32D4B38066A}" dt="2025-10-17T08:40:55.112" v="234" actId="478"/>
          <ac:spMkLst>
            <pc:docMk/>
            <pc:sldMk cId="3488421163" sldId="256"/>
            <ac:spMk id="53" creationId="{993E380C-35C3-DF03-5550-37E24D2E11C2}"/>
          </ac:spMkLst>
        </pc:spChg>
        <pc:spChg chg="del mod topLvl">
          <ac:chgData name="Midori IKEZAKI" userId="fd67c7cb21f100c9" providerId="LiveId" clId="{3A9434AE-C88A-430D-81D2-E32D4B38066A}" dt="2025-10-17T08:41:48.576" v="244" actId="478"/>
          <ac:spMkLst>
            <pc:docMk/>
            <pc:sldMk cId="3488421163" sldId="256"/>
            <ac:spMk id="54" creationId="{426EBEF0-4C02-9E2A-2355-675A11F2AC2D}"/>
          </ac:spMkLst>
        </pc:spChg>
        <pc:spChg chg="mod ord">
          <ac:chgData name="Midori IKEZAKI" userId="fd67c7cb21f100c9" providerId="LiveId" clId="{3A9434AE-C88A-430D-81D2-E32D4B38066A}" dt="2025-10-17T09:31:43.685" v="351" actId="1076"/>
          <ac:spMkLst>
            <pc:docMk/>
            <pc:sldMk cId="3488421163" sldId="256"/>
            <ac:spMk id="58" creationId="{F36F0F78-1A7C-A9C2-7B1B-DF7A89621FCE}"/>
          </ac:spMkLst>
        </pc:spChg>
        <pc:spChg chg="mod ord">
          <ac:chgData name="Midori IKEZAKI" userId="fd67c7cb21f100c9" providerId="LiveId" clId="{3A9434AE-C88A-430D-81D2-E32D4B38066A}" dt="2025-10-17T09:33:00.108" v="367" actId="14100"/>
          <ac:spMkLst>
            <pc:docMk/>
            <pc:sldMk cId="3488421163" sldId="256"/>
            <ac:spMk id="59" creationId="{F6148EB3-167C-9703-5634-7FF2F89D9360}"/>
          </ac:spMkLst>
        </pc:spChg>
        <pc:spChg chg="del mod">
          <ac:chgData name="Midori IKEZAKI" userId="fd67c7cb21f100c9" providerId="LiveId" clId="{3A9434AE-C88A-430D-81D2-E32D4B38066A}" dt="2025-10-17T08:39:31.913" v="183" actId="478"/>
          <ac:spMkLst>
            <pc:docMk/>
            <pc:sldMk cId="3488421163" sldId="256"/>
            <ac:spMk id="60" creationId="{7B4B8392-66CC-8FF9-3DF8-00C43D9E712F}"/>
          </ac:spMkLst>
        </pc:spChg>
        <pc:spChg chg="add del mod topLvl">
          <ac:chgData name="Midori IKEZAKI" userId="fd67c7cb21f100c9" providerId="LiveId" clId="{3A9434AE-C88A-430D-81D2-E32D4B38066A}" dt="2025-10-17T09:23:00.170" v="327" actId="478"/>
          <ac:spMkLst>
            <pc:docMk/>
            <pc:sldMk cId="3488421163" sldId="256"/>
            <ac:spMk id="61" creationId="{E7F4517A-04C6-C843-E813-4242BA9BB47B}"/>
          </ac:spMkLst>
        </pc:spChg>
        <pc:spChg chg="add del mod topLvl">
          <ac:chgData name="Midori IKEZAKI" userId="fd67c7cb21f100c9" providerId="LiveId" clId="{3A9434AE-C88A-430D-81D2-E32D4B38066A}" dt="2025-10-17T09:23:00.170" v="327" actId="478"/>
          <ac:spMkLst>
            <pc:docMk/>
            <pc:sldMk cId="3488421163" sldId="256"/>
            <ac:spMk id="62" creationId="{B236295D-19B3-5B36-4935-5FBC3F123783}"/>
          </ac:spMkLst>
        </pc:spChg>
        <pc:spChg chg="add del mod topLvl">
          <ac:chgData name="Midori IKEZAKI" userId="fd67c7cb21f100c9" providerId="LiveId" clId="{3A9434AE-C88A-430D-81D2-E32D4B38066A}" dt="2025-10-17T09:23:00.170" v="327" actId="478"/>
          <ac:spMkLst>
            <pc:docMk/>
            <pc:sldMk cId="3488421163" sldId="256"/>
            <ac:spMk id="65" creationId="{CD1EA606-8D94-B1FE-14AC-F063E83F36DA}"/>
          </ac:spMkLst>
        </pc:spChg>
        <pc:spChg chg="add del mod topLvl">
          <ac:chgData name="Midori IKEZAKI" userId="fd67c7cb21f100c9" providerId="LiveId" clId="{3A9434AE-C88A-430D-81D2-E32D4B38066A}" dt="2025-10-17T09:23:00.170" v="327" actId="478"/>
          <ac:spMkLst>
            <pc:docMk/>
            <pc:sldMk cId="3488421163" sldId="256"/>
            <ac:spMk id="66" creationId="{4106CDEF-335F-6E62-15D0-60CC817ACF53}"/>
          </ac:spMkLst>
        </pc:spChg>
        <pc:grpChg chg="mod">
          <ac:chgData name="Midori IKEZAKI" userId="fd67c7cb21f100c9" providerId="LiveId" clId="{3A9434AE-C88A-430D-81D2-E32D4B38066A}" dt="2025-10-17T08:38:40.256" v="173" actId="1076"/>
          <ac:grpSpMkLst>
            <pc:docMk/>
            <pc:sldMk cId="3488421163" sldId="256"/>
            <ac:grpSpMk id="39" creationId="{B38951FB-DB29-3963-EE8C-B669E7C90E37}"/>
          </ac:grpSpMkLst>
        </pc:grpChg>
        <pc:grpChg chg="mod">
          <ac:chgData name="Midori IKEZAKI" userId="fd67c7cb21f100c9" providerId="LiveId" clId="{3A9434AE-C88A-430D-81D2-E32D4B38066A}" dt="2025-10-17T08:39:14.995" v="179" actId="1076"/>
          <ac:grpSpMkLst>
            <pc:docMk/>
            <pc:sldMk cId="3488421163" sldId="256"/>
            <ac:grpSpMk id="50" creationId="{2FBDDB86-65A0-57BE-CF8D-2B8F90827BC5}"/>
          </ac:grpSpMkLst>
        </pc:grpChg>
        <pc:grpChg chg="add mod">
          <ac:chgData name="Midori IKEZAKI" userId="fd67c7cb21f100c9" providerId="LiveId" clId="{3A9434AE-C88A-430D-81D2-E32D4B38066A}" dt="2025-10-17T08:42:38.673" v="281" actId="164"/>
          <ac:grpSpMkLst>
            <pc:docMk/>
            <pc:sldMk cId="3488421163" sldId="256"/>
            <ac:grpSpMk id="67" creationId="{D4062B1F-CF82-1E96-33A7-E19F1E876BE2}"/>
          </ac:grpSpMkLst>
        </pc:grpChg>
        <pc:grpChg chg="add del mod">
          <ac:chgData name="Midori IKEZAKI" userId="fd67c7cb21f100c9" providerId="LiveId" clId="{3A9434AE-C88A-430D-81D2-E32D4B38066A}" dt="2025-10-17T08:42:55.204" v="284" actId="165"/>
          <ac:grpSpMkLst>
            <pc:docMk/>
            <pc:sldMk cId="3488421163" sldId="256"/>
            <ac:grpSpMk id="68" creationId="{750B9CAB-DAF5-7430-95D8-BADAFAE2C58B}"/>
          </ac:grpSpMkLst>
        </pc:grpChg>
        <pc:picChg chg="del mod">
          <ac:chgData name="Midori IKEZAKI" userId="fd67c7cb21f100c9" providerId="LiveId" clId="{3A9434AE-C88A-430D-81D2-E32D4B38066A}" dt="2025-10-17T08:28:12.801" v="98" actId="478"/>
          <ac:picMkLst>
            <pc:docMk/>
            <pc:sldMk cId="3488421163" sldId="256"/>
            <ac:picMk id="2" creationId="{BFAA86F0-BCFA-C4E4-F85B-DFCF2C9B6F3F}"/>
          </ac:picMkLst>
        </pc:picChg>
        <pc:picChg chg="del mod">
          <ac:chgData name="Midori IKEZAKI" userId="fd67c7cb21f100c9" providerId="LiveId" clId="{3A9434AE-C88A-430D-81D2-E32D4B38066A}" dt="2025-10-17T08:28:12.801" v="98" actId="478"/>
          <ac:picMkLst>
            <pc:docMk/>
            <pc:sldMk cId="3488421163" sldId="256"/>
            <ac:picMk id="4" creationId="{7F1BBEDA-3E35-2FC8-74E7-367E10047078}"/>
          </ac:picMkLst>
        </pc:picChg>
        <pc:picChg chg="add del mod">
          <ac:chgData name="Midori IKEZAKI" userId="fd67c7cb21f100c9" providerId="LiveId" clId="{3A9434AE-C88A-430D-81D2-E32D4B38066A}" dt="2025-10-17T09:30:24.513" v="343" actId="478"/>
          <ac:picMkLst>
            <pc:docMk/>
            <pc:sldMk cId="3488421163" sldId="256"/>
            <ac:picMk id="4" creationId="{8FB1E9F7-DE1D-5E6E-7AEE-8C9A9A8FB643}"/>
          </ac:picMkLst>
        </pc:picChg>
        <pc:picChg chg="del">
          <ac:chgData name="Midori IKEZAKI" userId="fd67c7cb21f100c9" providerId="LiveId" clId="{3A9434AE-C88A-430D-81D2-E32D4B38066A}" dt="2025-10-17T08:28:12.801" v="98" actId="478"/>
          <ac:picMkLst>
            <pc:docMk/>
            <pc:sldMk cId="3488421163" sldId="256"/>
            <ac:picMk id="6" creationId="{69286FB7-2FAE-74F5-296D-5E907452E33A}"/>
          </ac:picMkLst>
        </pc:picChg>
        <pc:picChg chg="add mod">
          <ac:chgData name="Midori IKEZAKI" userId="fd67c7cb21f100c9" providerId="LiveId" clId="{3A9434AE-C88A-430D-81D2-E32D4B38066A}" dt="2025-10-17T09:33:17.475" v="369" actId="208"/>
          <ac:picMkLst>
            <pc:docMk/>
            <pc:sldMk cId="3488421163" sldId="256"/>
            <ac:picMk id="7" creationId="{CF86C3EA-CF23-2EE0-242E-9062439E90C3}"/>
          </ac:picMkLst>
        </pc:picChg>
        <pc:picChg chg="del">
          <ac:chgData name="Midori IKEZAKI" userId="fd67c7cb21f100c9" providerId="LiveId" clId="{3A9434AE-C88A-430D-81D2-E32D4B38066A}" dt="2025-10-17T08:28:12.801" v="98" actId="478"/>
          <ac:picMkLst>
            <pc:docMk/>
            <pc:sldMk cId="3488421163" sldId="256"/>
            <ac:picMk id="8" creationId="{002BEEC8-A156-FAAA-F799-BBD0643CCF04}"/>
          </ac:picMkLst>
        </pc:picChg>
        <pc:picChg chg="add del mod">
          <ac:chgData name="Midori IKEZAKI" userId="fd67c7cb21f100c9" providerId="LiveId" clId="{3A9434AE-C88A-430D-81D2-E32D4B38066A}" dt="2025-10-17T09:27:33.322" v="331" actId="478"/>
          <ac:picMkLst>
            <pc:docMk/>
            <pc:sldMk cId="3488421163" sldId="256"/>
            <ac:picMk id="9" creationId="{7F78248E-0BB5-2AA9-9469-42EAB0F4A278}"/>
          </ac:picMkLst>
        </pc:picChg>
        <pc:picChg chg="del">
          <ac:chgData name="Midori IKEZAKI" userId="fd67c7cb21f100c9" providerId="LiveId" clId="{3A9434AE-C88A-430D-81D2-E32D4B38066A}" dt="2025-10-17T08:28:12.801" v="98" actId="478"/>
          <ac:picMkLst>
            <pc:docMk/>
            <pc:sldMk cId="3488421163" sldId="256"/>
            <ac:picMk id="10" creationId="{7EDC004E-110C-F71D-E2E6-6E8F76AE8FB4}"/>
          </ac:picMkLst>
        </pc:picChg>
        <pc:picChg chg="add mod">
          <ac:chgData name="Midori IKEZAKI" userId="fd67c7cb21f100c9" providerId="LiveId" clId="{3A9434AE-C88A-430D-81D2-E32D4B38066A}" dt="2025-10-17T09:33:13.943" v="368" actId="208"/>
          <ac:picMkLst>
            <pc:docMk/>
            <pc:sldMk cId="3488421163" sldId="256"/>
            <ac:picMk id="11" creationId="{BD1CD6FC-11E8-7838-231E-89D2BE338ED2}"/>
          </ac:picMkLst>
        </pc:picChg>
        <pc:picChg chg="del mod">
          <ac:chgData name="Midori IKEZAKI" userId="fd67c7cb21f100c9" providerId="LiveId" clId="{3A9434AE-C88A-430D-81D2-E32D4B38066A}" dt="2025-10-17T08:28:12.801" v="98" actId="478"/>
          <ac:picMkLst>
            <pc:docMk/>
            <pc:sldMk cId="3488421163" sldId="256"/>
            <ac:picMk id="12" creationId="{064817C6-D0A2-4CB3-31EC-54EDB4626851}"/>
          </ac:picMkLst>
        </pc:picChg>
        <pc:picChg chg="del">
          <ac:chgData name="Midori IKEZAKI" userId="fd67c7cb21f100c9" providerId="LiveId" clId="{3A9434AE-C88A-430D-81D2-E32D4B38066A}" dt="2025-10-17T08:26:35.337" v="81" actId="478"/>
          <ac:picMkLst>
            <pc:docMk/>
            <pc:sldMk cId="3488421163" sldId="256"/>
            <ac:picMk id="14" creationId="{EAFE8A96-3E07-E156-57FF-22D05EEFBBB8}"/>
          </ac:picMkLst>
        </pc:picChg>
        <pc:picChg chg="add mod">
          <ac:chgData name="Midori IKEZAKI" userId="fd67c7cb21f100c9" providerId="LiveId" clId="{3A9434AE-C88A-430D-81D2-E32D4B38066A}" dt="2025-10-17T08:41:07.768" v="241" actId="552"/>
          <ac:picMkLst>
            <pc:docMk/>
            <pc:sldMk cId="3488421163" sldId="256"/>
            <ac:picMk id="21" creationId="{DDD9E8C0-B788-037F-FAF2-55335EEDE94A}"/>
          </ac:picMkLst>
        </pc:picChg>
        <pc:picChg chg="add mod">
          <ac:chgData name="Midori IKEZAKI" userId="fd67c7cb21f100c9" providerId="LiveId" clId="{3A9434AE-C88A-430D-81D2-E32D4B38066A}" dt="2025-10-17T08:39:47.033" v="194" actId="552"/>
          <ac:picMkLst>
            <pc:docMk/>
            <pc:sldMk cId="3488421163" sldId="256"/>
            <ac:picMk id="23" creationId="{804C64A5-D9D6-9F9A-8848-2923E1C80F92}"/>
          </ac:picMkLst>
        </pc:picChg>
        <pc:picChg chg="add mod">
          <ac:chgData name="Midori IKEZAKI" userId="fd67c7cb21f100c9" providerId="LiveId" clId="{3A9434AE-C88A-430D-81D2-E32D4B38066A}" dt="2025-10-17T08:39:58.194" v="199" actId="552"/>
          <ac:picMkLst>
            <pc:docMk/>
            <pc:sldMk cId="3488421163" sldId="256"/>
            <ac:picMk id="25" creationId="{49D1DD05-EC26-4F11-B2EA-CD412EC6094B}"/>
          </ac:picMkLst>
        </pc:picChg>
        <pc:picChg chg="add del mod">
          <ac:chgData name="Midori IKEZAKI" userId="fd67c7cb21f100c9" providerId="LiveId" clId="{3A9434AE-C88A-430D-81D2-E32D4B38066A}" dt="2025-10-17T08:45:39.918" v="294" actId="478"/>
          <ac:picMkLst>
            <pc:docMk/>
            <pc:sldMk cId="3488421163" sldId="256"/>
            <ac:picMk id="33" creationId="{F1536B3D-F600-DF65-10F8-8F71A121433B}"/>
          </ac:picMkLst>
        </pc:picChg>
        <pc:picChg chg="add del mod">
          <ac:chgData name="Midori IKEZAKI" userId="fd67c7cb21f100c9" providerId="LiveId" clId="{3A9434AE-C88A-430D-81D2-E32D4B38066A}" dt="2025-10-17T08:47:07.696" v="312" actId="478"/>
          <ac:picMkLst>
            <pc:docMk/>
            <pc:sldMk cId="3488421163" sldId="256"/>
            <ac:picMk id="34" creationId="{2E02CE5E-79AF-0086-C85C-F79A610B37D2}"/>
          </ac:picMkLst>
        </pc:picChg>
        <pc:picChg chg="add del mod">
          <ac:chgData name="Midori IKEZAKI" userId="fd67c7cb21f100c9" providerId="LiveId" clId="{3A9434AE-C88A-430D-81D2-E32D4B38066A}" dt="2025-10-17T08:39:28.032" v="182" actId="478"/>
          <ac:picMkLst>
            <pc:docMk/>
            <pc:sldMk cId="3488421163" sldId="256"/>
            <ac:picMk id="35" creationId="{2A197C06-95B9-716C-A053-0E6578ABC192}"/>
          </ac:picMkLst>
        </pc:picChg>
        <pc:picChg chg="add mod">
          <ac:chgData name="Midori IKEZAKI" userId="fd67c7cb21f100c9" providerId="LiveId" clId="{3A9434AE-C88A-430D-81D2-E32D4B38066A}" dt="2025-10-17T08:38:42.861" v="174"/>
          <ac:picMkLst>
            <pc:docMk/>
            <pc:sldMk cId="3488421163" sldId="256"/>
            <ac:picMk id="44" creationId="{03785A58-8A9E-41AF-9C1A-14419275D0D2}"/>
          </ac:picMkLst>
        </pc:picChg>
        <pc:picChg chg="add mod">
          <ac:chgData name="Midori IKEZAKI" userId="fd67c7cb21f100c9" providerId="LiveId" clId="{3A9434AE-C88A-430D-81D2-E32D4B38066A}" dt="2025-10-17T08:38:42.861" v="174"/>
          <ac:picMkLst>
            <pc:docMk/>
            <pc:sldMk cId="3488421163" sldId="256"/>
            <ac:picMk id="45" creationId="{41B1B97B-24DF-C8F5-3952-107DD1E2E2BE}"/>
          </ac:picMkLst>
        </pc:picChg>
        <pc:picChg chg="add mod">
          <ac:chgData name="Midori IKEZAKI" userId="fd67c7cb21f100c9" providerId="LiveId" clId="{3A9434AE-C88A-430D-81D2-E32D4B38066A}" dt="2025-10-17T08:38:42.861" v="174"/>
          <ac:picMkLst>
            <pc:docMk/>
            <pc:sldMk cId="3488421163" sldId="256"/>
            <ac:picMk id="46" creationId="{55588C3A-B1E4-1957-290E-E8937567C054}"/>
          </ac:picMkLst>
        </pc:picChg>
        <pc:picChg chg="del mod">
          <ac:chgData name="Midori IKEZAKI" userId="fd67c7cb21f100c9" providerId="LiveId" clId="{3A9434AE-C88A-430D-81D2-E32D4B38066A}" dt="2025-10-17T09:27:43.642" v="334" actId="478"/>
          <ac:picMkLst>
            <pc:docMk/>
            <pc:sldMk cId="3488421163" sldId="256"/>
            <ac:picMk id="55" creationId="{D2CE1F51-EF27-090E-24A8-70A37A5B9238}"/>
          </ac:picMkLst>
        </pc:picChg>
        <pc:picChg chg="del mod">
          <ac:chgData name="Midori IKEZAKI" userId="fd67c7cb21f100c9" providerId="LiveId" clId="{3A9434AE-C88A-430D-81D2-E32D4B38066A}" dt="2025-10-17T09:28:07.988" v="339" actId="478"/>
          <ac:picMkLst>
            <pc:docMk/>
            <pc:sldMk cId="3488421163" sldId="256"/>
            <ac:picMk id="56" creationId="{DA0D1D8C-B2E4-85FA-F073-E602163DA889}"/>
          </ac:picMkLst>
        </pc:picChg>
        <pc:picChg chg="del mod">
          <ac:chgData name="Midori IKEZAKI" userId="fd67c7cb21f100c9" providerId="LiveId" clId="{3A9434AE-C88A-430D-81D2-E32D4B38066A}" dt="2025-10-17T08:39:28.032" v="182" actId="478"/>
          <ac:picMkLst>
            <pc:docMk/>
            <pc:sldMk cId="3488421163" sldId="256"/>
            <ac:picMk id="57" creationId="{D2EE744A-9203-6B9C-F801-FC5514B7E0C8}"/>
          </ac:picMkLst>
        </pc:picChg>
        <pc:picChg chg="add del mod topLvl">
          <ac:chgData name="Midori IKEZAKI" userId="fd67c7cb21f100c9" providerId="LiveId" clId="{3A9434AE-C88A-430D-81D2-E32D4B38066A}" dt="2025-10-17T09:23:00.170" v="327" actId="478"/>
          <ac:picMkLst>
            <pc:docMk/>
            <pc:sldMk cId="3488421163" sldId="256"/>
            <ac:picMk id="63" creationId="{7CB38C94-9176-F2B3-ECE8-F699DC74846B}"/>
          </ac:picMkLst>
        </pc:picChg>
        <pc:picChg chg="add del mod topLvl">
          <ac:chgData name="Midori IKEZAKI" userId="fd67c7cb21f100c9" providerId="LiveId" clId="{3A9434AE-C88A-430D-81D2-E32D4B38066A}" dt="2025-10-17T09:23:00.170" v="327" actId="478"/>
          <ac:picMkLst>
            <pc:docMk/>
            <pc:sldMk cId="3488421163" sldId="256"/>
            <ac:picMk id="64" creationId="{3B01EA9F-B54D-9D47-E4BB-C907A8AFCCC0}"/>
          </ac:picMkLst>
        </pc:picChg>
        <pc:picChg chg="add mod">
          <ac:chgData name="Midori IKEZAKI" userId="fd67c7cb21f100c9" providerId="LiveId" clId="{3A9434AE-C88A-430D-81D2-E32D4B38066A}" dt="2025-10-17T09:31:14.713" v="348" actId="552"/>
          <ac:picMkLst>
            <pc:docMk/>
            <pc:sldMk cId="3488421163" sldId="256"/>
            <ac:picMk id="70" creationId="{86ACDEDB-8A00-7D0A-5929-9D3E4694BF6A}"/>
          </ac:picMkLst>
        </pc:picChg>
        <pc:picChg chg="add mod ord">
          <ac:chgData name="Midori IKEZAKI" userId="fd67c7cb21f100c9" providerId="LiveId" clId="{3A9434AE-C88A-430D-81D2-E32D4B38066A}" dt="2025-10-17T08:47:37.689" v="318" actId="208"/>
          <ac:picMkLst>
            <pc:docMk/>
            <pc:sldMk cId="3488421163" sldId="256"/>
            <ac:picMk id="72" creationId="{8C74639A-CAE4-F5BA-6369-10A367A7247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227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3967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72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194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3322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153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683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8353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972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103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413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F4332-D7BD-46D2-9BD4-8C15139219A2}" type="datetimeFigureOut">
              <a:rPr kumimoji="1" lang="ja-JP" altLang="en-US" smtClean="0"/>
              <a:t>2025/10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26694-E436-4A6A-885D-0C5204F33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581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図 71">
            <a:extLst>
              <a:ext uri="{FF2B5EF4-FFF2-40B4-BE49-F238E27FC236}">
                <a16:creationId xmlns:a16="http://schemas.microsoft.com/office/drawing/2014/main" id="{8C74639A-CAE4-F5BA-6369-10A367A724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0000" y="3239792"/>
            <a:ext cx="2067120" cy="15444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D573505-69E2-F1D2-8E9F-55E752B7BB4B}"/>
              </a:ext>
            </a:extLst>
          </p:cNvPr>
          <p:cNvSpPr txBox="1"/>
          <p:nvPr/>
        </p:nvSpPr>
        <p:spPr>
          <a:xfrm>
            <a:off x="360000" y="920812"/>
            <a:ext cx="1003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BACE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EB9518A-CAE2-6D0B-7EC5-E9FF94289598}"/>
              </a:ext>
            </a:extLst>
          </p:cNvPr>
          <p:cNvSpPr txBox="1"/>
          <p:nvPr/>
        </p:nvSpPr>
        <p:spPr>
          <a:xfrm>
            <a:off x="4680000" y="920812"/>
            <a:ext cx="97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9AFF4E7-D4FF-E0E0-2529-D8F6F66AB7F5}"/>
              </a:ext>
            </a:extLst>
          </p:cNvPr>
          <p:cNvSpPr txBox="1"/>
          <p:nvPr/>
        </p:nvSpPr>
        <p:spPr>
          <a:xfrm>
            <a:off x="2520000" y="902904"/>
            <a:ext cx="982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HIF1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A6DEDFE-923D-1023-05B1-8BCD91B1029E}"/>
              </a:ext>
            </a:extLst>
          </p:cNvPr>
          <p:cNvSpPr txBox="1"/>
          <p:nvPr/>
        </p:nvSpPr>
        <p:spPr>
          <a:xfrm>
            <a:off x="340709" y="243486"/>
            <a:ext cx="537129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We saved the amounts of primary CTB samples for Western blotting. </a:t>
            </a:r>
            <a:r>
              <a:rPr lang="en-US" altLang="ja-JP" sz="1100" dirty="0"/>
              <a:t>Thus, we cut the membranes based on the molecular weights of the target proteins.</a:t>
            </a:r>
            <a:r>
              <a:rPr kumimoji="1" lang="en-US" altLang="ja-JP" sz="1100" dirty="0"/>
              <a:t> </a:t>
            </a:r>
            <a:endParaRPr kumimoji="1" lang="ja-JP" altLang="en-US" sz="11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34CEBAE-4CAA-CD76-CA8F-1CFAC9266987}"/>
              </a:ext>
            </a:extLst>
          </p:cNvPr>
          <p:cNvSpPr txBox="1"/>
          <p:nvPr/>
        </p:nvSpPr>
        <p:spPr>
          <a:xfrm>
            <a:off x="180000" y="67973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DDD9E8C0-B788-037F-FAF2-55335EEDE9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00" y="1219734"/>
            <a:ext cx="2067581" cy="150552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804C64A5-D9D6-9F9A-8848-2923E1C80F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20000" y="1219734"/>
            <a:ext cx="2067581" cy="150552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49D1DD05-EC26-4F11-B2EA-CD412EC6094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0000" y="1219734"/>
            <a:ext cx="2067581" cy="150552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C87300B2-D62E-F008-BB10-4F2D6D9FCE15}"/>
              </a:ext>
            </a:extLst>
          </p:cNvPr>
          <p:cNvSpPr/>
          <p:nvPr/>
        </p:nvSpPr>
        <p:spPr>
          <a:xfrm>
            <a:off x="1169873" y="1815726"/>
            <a:ext cx="188856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50C7B2F7-0C9D-72E3-0414-26EF9523BC6E}"/>
              </a:ext>
            </a:extLst>
          </p:cNvPr>
          <p:cNvSpPr/>
          <p:nvPr/>
        </p:nvSpPr>
        <p:spPr>
          <a:xfrm>
            <a:off x="3342325" y="1810557"/>
            <a:ext cx="188856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9C7E0361-1131-C93C-4B7B-7E667B4D9C7F}"/>
              </a:ext>
            </a:extLst>
          </p:cNvPr>
          <p:cNvSpPr/>
          <p:nvPr/>
        </p:nvSpPr>
        <p:spPr>
          <a:xfrm>
            <a:off x="5327125" y="1858318"/>
            <a:ext cx="188856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AC5F521-F40E-43E1-E0CE-F6AB1E6AFD4E}"/>
              </a:ext>
            </a:extLst>
          </p:cNvPr>
          <p:cNvSpPr txBox="1"/>
          <p:nvPr/>
        </p:nvSpPr>
        <p:spPr>
          <a:xfrm>
            <a:off x="360000" y="2940870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A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0/4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AD1522D-9908-49D9-4F6B-AD39C4D99F65}"/>
              </a:ext>
            </a:extLst>
          </p:cNvPr>
          <p:cNvSpPr txBox="1"/>
          <p:nvPr/>
        </p:nvSpPr>
        <p:spPr>
          <a:xfrm>
            <a:off x="2520000" y="2940870"/>
            <a:ext cx="97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63C0BB3-E283-30AF-2B29-B1B9AE05D7B6}"/>
              </a:ext>
            </a:extLst>
          </p:cNvPr>
          <p:cNvSpPr txBox="1"/>
          <p:nvPr/>
        </p:nvSpPr>
        <p:spPr>
          <a:xfrm>
            <a:off x="180000" y="269979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D668C4BC-406A-5417-8227-C4A33A78EDDA}"/>
              </a:ext>
            </a:extLst>
          </p:cNvPr>
          <p:cNvSpPr/>
          <p:nvPr/>
        </p:nvSpPr>
        <p:spPr>
          <a:xfrm>
            <a:off x="2966087" y="3887765"/>
            <a:ext cx="188856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CC1F5FF-424A-1FCD-61DE-15821A5F2DC3}"/>
              </a:ext>
            </a:extLst>
          </p:cNvPr>
          <p:cNvSpPr txBox="1"/>
          <p:nvPr/>
        </p:nvSpPr>
        <p:spPr>
          <a:xfrm>
            <a:off x="360000" y="4751872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A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0/42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FDFE399-9CBB-18E8-65E9-51FE8298F899}"/>
              </a:ext>
            </a:extLst>
          </p:cNvPr>
          <p:cNvSpPr txBox="1"/>
          <p:nvPr/>
        </p:nvSpPr>
        <p:spPr>
          <a:xfrm>
            <a:off x="2520000" y="4751872"/>
            <a:ext cx="97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en-US" altLang="ja-JP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図 69">
            <a:extLst>
              <a:ext uri="{FF2B5EF4-FFF2-40B4-BE49-F238E27FC236}">
                <a16:creationId xmlns:a16="http://schemas.microsoft.com/office/drawing/2014/main" id="{86ACDEDB-8A00-7D0A-5929-9D3E4694BF6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000" y="3239792"/>
            <a:ext cx="2066400" cy="15438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D2756521-44B3-26A3-A682-7F164C0778C7}"/>
              </a:ext>
            </a:extLst>
          </p:cNvPr>
          <p:cNvSpPr/>
          <p:nvPr/>
        </p:nvSpPr>
        <p:spPr>
          <a:xfrm>
            <a:off x="1017811" y="4073812"/>
            <a:ext cx="288032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CF86C3EA-CF23-2EE0-242E-9062439E90C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20000" y="5050794"/>
            <a:ext cx="2066400" cy="15438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F6148EB3-167C-9703-5634-7FF2F89D9360}"/>
              </a:ext>
            </a:extLst>
          </p:cNvPr>
          <p:cNvSpPr/>
          <p:nvPr/>
        </p:nvSpPr>
        <p:spPr>
          <a:xfrm>
            <a:off x="2952112" y="5580112"/>
            <a:ext cx="234000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BD1CD6FC-11E8-7838-231E-89D2BE338ED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0000" y="5050794"/>
            <a:ext cx="2066400" cy="154386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F36F0F78-1A7C-A9C2-7B1B-DF7A89621FCE}"/>
              </a:ext>
            </a:extLst>
          </p:cNvPr>
          <p:cNvSpPr/>
          <p:nvPr/>
        </p:nvSpPr>
        <p:spPr>
          <a:xfrm>
            <a:off x="753559" y="5883832"/>
            <a:ext cx="188856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D3973391-A468-ACBF-236D-043F6321C1FB}"/>
              </a:ext>
            </a:extLst>
          </p:cNvPr>
          <p:cNvSpPr/>
          <p:nvPr/>
        </p:nvSpPr>
        <p:spPr>
          <a:xfrm>
            <a:off x="1356659" y="5867219"/>
            <a:ext cx="188856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BE4280CB-753E-A1DF-90A3-90CF988B7A1A}"/>
              </a:ext>
            </a:extLst>
          </p:cNvPr>
          <p:cNvSpPr/>
          <p:nvPr/>
        </p:nvSpPr>
        <p:spPr>
          <a:xfrm>
            <a:off x="3632359" y="5580111"/>
            <a:ext cx="216000" cy="134973"/>
          </a:xfrm>
          <a:prstGeom prst="rect">
            <a:avLst/>
          </a:prstGeom>
          <a:noFill/>
          <a:ln w="63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421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37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Symbol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chika</dc:creator>
  <cp:lastModifiedBy>Midori IKEZAKI</cp:lastModifiedBy>
  <cp:revision>22</cp:revision>
  <cp:lastPrinted>2018-01-18T04:25:13Z</cp:lastPrinted>
  <dcterms:created xsi:type="dcterms:W3CDTF">2016-04-05T01:33:39Z</dcterms:created>
  <dcterms:modified xsi:type="dcterms:W3CDTF">2025-10-20T00:23:01Z</dcterms:modified>
</cp:coreProperties>
</file>